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02" r:id="rId2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869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73" autoAdjust="0"/>
    <p:restoredTop sz="74510" autoAdjust="0"/>
  </p:normalViewPr>
  <p:slideViewPr>
    <p:cSldViewPr snapToGrid="0">
      <p:cViewPr varScale="1">
        <p:scale>
          <a:sx n="61" d="100"/>
          <a:sy n="61" d="100"/>
        </p:scale>
        <p:origin x="2670" y="66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8B7A6-A418-4C37-8DE7-370EEF89986F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0C8CD-7C34-44D0-AB1A-3784C5385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220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 S5: Effects of NCGC00188758 treatment on glucocerebrosidase activity in healthy control PBMCs compared to vehicle treatment</a:t>
            </a:r>
            <a:r>
              <a:rPr lang="en-US" sz="18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Bar graph overlaid with scatter plot showing calculated GBA index as a measure of GCase activity. GBA index was calculated by using the MFI of cleaved GCase substrate PFB-FDglu in vehicle or NCG treated conditions and subtracting the background MFI observed in the conduritol B-epoxide treated conditions for each sample. Bars represent mean +/- SEM. Healthy controls, </a:t>
            </a:r>
            <a:r>
              <a:rPr lang="en-US" sz="18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8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0. Each symbol represents the measurement from a single individual. Results were analyzed using an unpaired parametric t-test. </a:t>
            </a:r>
            <a:endParaRPr lang="en-US" sz="1800" b="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F0C8CD-7C34-44D0-AB1A-3784C53859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929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878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385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986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11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260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196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14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3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077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813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174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944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794578-BF83-A52B-02DF-EF6925412BE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F12BD1F-CE59-370E-F4B7-6AA829A3E827}"/>
              </a:ext>
            </a:extLst>
          </p:cNvPr>
          <p:cNvSpPr txBox="1"/>
          <p:nvPr/>
        </p:nvSpPr>
        <p:spPr>
          <a:xfrm>
            <a:off x="0" y="0"/>
            <a:ext cx="82671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/>
              <a:t>Fig. S5</a:t>
            </a:r>
            <a:endParaRPr lang="en-US" sz="24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16D4ED6-8C74-B51B-521C-712706E74E3B}"/>
              </a:ext>
            </a:extLst>
          </p:cNvPr>
          <p:cNvSpPr txBox="1"/>
          <p:nvPr/>
        </p:nvSpPr>
        <p:spPr>
          <a:xfrm>
            <a:off x="140329" y="3979985"/>
            <a:ext cx="6795321" cy="1919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 S5: Effects of NCGC00188758 treatment on glucocerebrosidase activity in healthy control PBMCs compared to vehicle treatment</a:t>
            </a:r>
            <a:r>
              <a:rPr lang="en-US" sz="14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Bar graph overlaid with scatter plot showing calculated GBA index as a measure of GCase activity. GBA index was calculated by using the MFI of cleaved GCase substrate PFB-FDglu in vehicle or NCG treated conditions and subtracting the background MFI observed in the conduritol B-epoxide treated conditions for each sample. Bars represent mean +/- SEM. Healthy controls, </a:t>
            </a:r>
            <a:r>
              <a:rPr lang="en-US" sz="14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4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0. Each symbol represents the measurement from a single individual. Results were analyzed using an unpaired parametric t-test. </a:t>
            </a:r>
            <a:endParaRPr lang="en-US" sz="1400" b="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39E4AF0-33E1-870E-B8B6-7723F49CBD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8725" y="200105"/>
            <a:ext cx="2765328" cy="3779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5961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86</TotalTime>
  <Words>210</Words>
  <Application>Microsoft Office PowerPoint</Application>
  <PresentationFormat>Custom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RRK2/GBA1 mutations peripheral immune cells in Parkinson’s disease</dc:title>
  <dc:creator>Julian Mark</dc:creator>
  <cp:lastModifiedBy>Mark, Julian</cp:lastModifiedBy>
  <cp:revision>803</cp:revision>
  <dcterms:created xsi:type="dcterms:W3CDTF">2025-01-19T15:31:25Z</dcterms:created>
  <dcterms:modified xsi:type="dcterms:W3CDTF">2025-10-25T20:12:41Z</dcterms:modified>
</cp:coreProperties>
</file>